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grid Olsson" userId="076488fb-c782-486d-939f-7af96eec1992" providerId="ADAL" clId="{3F48186C-5A53-4B64-8B58-9EC086909707}"/>
    <pc:docChg chg="modSld">
      <pc:chgData name="Ingrid Olsson" userId="076488fb-c782-486d-939f-7af96eec1992" providerId="ADAL" clId="{3F48186C-5A53-4B64-8B58-9EC086909707}" dt="2025-03-21T14:00:25.848" v="17" actId="20577"/>
      <pc:docMkLst>
        <pc:docMk/>
      </pc:docMkLst>
      <pc:sldChg chg="modSp mod">
        <pc:chgData name="Ingrid Olsson" userId="076488fb-c782-486d-939f-7af96eec1992" providerId="ADAL" clId="{3F48186C-5A53-4B64-8B58-9EC086909707}" dt="2025-03-21T14:00:25.848" v="17" actId="20577"/>
        <pc:sldMkLst>
          <pc:docMk/>
          <pc:sldMk cId="117245953" sldId="256"/>
        </pc:sldMkLst>
        <pc:spChg chg="mod">
          <ac:chgData name="Ingrid Olsson" userId="076488fb-c782-486d-939f-7af96eec1992" providerId="ADAL" clId="{3F48186C-5A53-4B64-8B58-9EC086909707}" dt="2025-03-21T13:57:59.580" v="0" actId="790"/>
          <ac:spMkLst>
            <pc:docMk/>
            <pc:sldMk cId="117245953" sldId="256"/>
            <ac:spMk id="7" creationId="{B0122905-3DFA-4CF6-1040-DD2BD77CEC98}"/>
          </ac:spMkLst>
        </pc:spChg>
        <pc:spChg chg="mod">
          <ac:chgData name="Ingrid Olsson" userId="076488fb-c782-486d-939f-7af96eec1992" providerId="ADAL" clId="{3F48186C-5A53-4B64-8B58-9EC086909707}" dt="2025-03-21T14:00:17.809" v="11" actId="20577"/>
          <ac:spMkLst>
            <pc:docMk/>
            <pc:sldMk cId="117245953" sldId="256"/>
            <ac:spMk id="22" creationId="{F78D6070-1FA4-9373-3153-8261B5CF6604}"/>
          </ac:spMkLst>
        </pc:spChg>
        <pc:spChg chg="mod">
          <ac:chgData name="Ingrid Olsson" userId="076488fb-c782-486d-939f-7af96eec1992" providerId="ADAL" clId="{3F48186C-5A53-4B64-8B58-9EC086909707}" dt="2025-03-21T14:00:23.018" v="16" actId="20577"/>
          <ac:spMkLst>
            <pc:docMk/>
            <pc:sldMk cId="117245953" sldId="256"/>
            <ac:spMk id="23" creationId="{9A6A929D-1DF8-A204-4C6A-8572858D564C}"/>
          </ac:spMkLst>
        </pc:spChg>
        <pc:spChg chg="mod">
          <ac:chgData name="Ingrid Olsson" userId="076488fb-c782-486d-939f-7af96eec1992" providerId="ADAL" clId="{3F48186C-5A53-4B64-8B58-9EC086909707}" dt="2025-03-21T14:00:25.848" v="17" actId="20577"/>
          <ac:spMkLst>
            <pc:docMk/>
            <pc:sldMk cId="117245953" sldId="256"/>
            <ac:spMk id="24" creationId="{0E4EAA72-223C-BF36-D1CA-72D7EB2CEC7E}"/>
          </ac:spMkLst>
        </pc:spChg>
        <pc:spChg chg="mod">
          <ac:chgData name="Ingrid Olsson" userId="076488fb-c782-486d-939f-7af96eec1992" providerId="ADAL" clId="{3F48186C-5A53-4B64-8B58-9EC086909707}" dt="2025-03-21T13:58:09.050" v="1" actId="790"/>
          <ac:spMkLst>
            <pc:docMk/>
            <pc:sldMk cId="117245953" sldId="256"/>
            <ac:spMk id="25" creationId="{F04235D1-9334-D95F-9E63-62BBE587519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70E01-33A9-DD46-BF57-505BC603A4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42E031-055F-EE15-E792-7D739AA37B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EA258C-6332-2938-6FA4-7B1F276FF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CB6E7-85A7-A577-19CB-D83653D7F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57EACC-D792-4CB2-166B-DC54586E2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27739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2371D-31CF-19C6-C28F-9E84EE2C1A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64EBCD-F8E3-D413-FFCA-FA60E83AE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F1DAC3-3503-50CF-7012-F398FD922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18875-7815-3A9A-BD80-1608345AE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ED67CD-7DF7-34F6-F0F6-5ACDA0A6C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8710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34A7F1-C34C-1FCC-5F78-14FE51556D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667B46-FA6C-87EE-5EED-F2C1BC85B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81AC4E-60E3-F400-3C02-A1FD59A29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CC3060-0FED-E02E-A6A1-AB993BEDC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408CB4-877C-2D71-2C85-7AEAA9C57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194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28EBD-1B83-80A5-8CE2-E3F7243401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7124EA-663D-F1BE-80B4-03928B5EC2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ACB30F-C029-1D9E-67F0-AF6BC93D4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96ADD1-53F3-199E-A593-76DEEE016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3F5A5-C2BD-60EA-39DC-FB4467867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95590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FD8C0-11EE-2928-0433-92E23F5D8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6B22D7-0412-13AB-5190-BC7D16910F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FD3AEA-129F-AD09-B764-E512102D4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B0CE9B-235A-856E-48C0-8486320D5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BD3CAB-71B1-672E-9B32-0AFC458FE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312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ACF47-42B6-6B83-65F6-9CE195004C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63C6C0-0C5C-5A2C-CE54-408ADD2754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92BE19-8BEE-DB19-7151-9D1676D52F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91BCDC-212C-2479-370D-49EE17929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0F6BEA-962D-A0F8-3001-E078E4471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3BEB03-A332-F275-0704-6BB2F1F2F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28867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998C7-1FB7-4D27-24A9-5CCDD04F4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DBCA8D-591F-E8E1-4EF4-D13EE678A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2C7DD5-4FDA-50AD-8A28-284DBC26B9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D9052D-2AA9-95D4-8FBD-62FB5D9E45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D6B1D1-8146-A3CE-3452-D96FACC15D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A74DE8-05E0-5FA8-74DF-6870C106D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8B9449-784C-5F19-DE48-C7CB38B14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E44C10-8B5D-D3F3-4167-8C25F3BE0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97567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4341E-CD74-F150-CEBF-30DA387C9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642DD6-3551-630C-98AE-A9C80BE1B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77F875-69B4-072F-3266-2EDBA4579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7F0E8E-BA70-D63C-8F5F-2DFEAF5AC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95177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21A92F-1985-386D-680F-BCD0F4955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F1B24B-C444-1D58-AC8D-1368D5C47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6EF289-3EBD-0DA7-F8D8-AC7698104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8761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2821E-E1C7-8F22-459B-7FE6085F3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6DB53A-1982-E34F-C0F4-6415186102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CBDD5A-A9F9-E852-278D-498E679FB6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CFB5E-8653-02C0-5E8E-CE85C8941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8D2E24-BE32-AA23-75ED-07159C737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A06851-6E1B-DB96-9A9C-FF5FB9C08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21513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48866-DC28-44F6-F038-EBEE8FD868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A74DFB-B079-6804-6BBA-6BA0613390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1ACF79-8005-AE2C-4C28-36CC50DC46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F02C0-5F38-1995-D2F9-5F8840381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A337E9-6D23-E73E-5090-A54510E1D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3B1127-2AB7-6BAC-628B-FE739335F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47609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DBF340-DC24-866B-36F3-4B417999BD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CA68FD-3812-B99C-1AC2-4B916AD34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AF47CB-6814-EC6A-8F4E-12F76577E4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3E4BB-E629-470E-9CF5-E53759BB5163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FA5D24-B3BA-6C24-79BA-D20C65F94E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1A93AB-5B56-0AE8-3151-5BE8C320E4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A0F7F7-F6A8-4123-A262-F28A14497FCB}" type="slidenum">
              <a:rPr lang="sv-SE" smtClean="0"/>
              <a:t>‹#›</a:t>
            </a:fld>
            <a:endParaRPr lang="sv-S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FC3D61-77F6-2197-2796-5480382E8573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11363325" y="63500"/>
            <a:ext cx="787400" cy="12192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GB" sz="800">
                <a:solidFill>
                  <a:srgbClr val="000000">
                    <a:alpha val="50000"/>
                  </a:srgb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egränsad delning</a:t>
            </a:r>
          </a:p>
        </p:txBody>
      </p:sp>
    </p:spTree>
    <p:extLst>
      <p:ext uri="{BB962C8B-B14F-4D97-AF65-F5344CB8AC3E}">
        <p14:creationId xmlns:p14="http://schemas.microsoft.com/office/powerpoint/2010/main" val="3128624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ktangel 3">
            <a:extLst>
              <a:ext uri="{FF2B5EF4-FFF2-40B4-BE49-F238E27FC236}">
                <a16:creationId xmlns:a16="http://schemas.microsoft.com/office/drawing/2014/main" id="{6FB63949-59C5-FC41-E186-2598D3103F1E}"/>
              </a:ext>
            </a:extLst>
          </p:cNvPr>
          <p:cNvSpPr/>
          <p:nvPr/>
        </p:nvSpPr>
        <p:spPr>
          <a:xfrm>
            <a:off x="1777999" y="1082842"/>
            <a:ext cx="3989137" cy="770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vey sent to a cohort of 1117 participants in the HAI Study</a:t>
            </a:r>
            <a:endParaRPr lang="en-GB" sz="11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ktangel 5">
            <a:extLst>
              <a:ext uri="{FF2B5EF4-FFF2-40B4-BE49-F238E27FC236}">
                <a16:creationId xmlns:a16="http://schemas.microsoft.com/office/drawing/2014/main" id="{6CCC0FB8-8B2F-079C-AE7F-E4588A14D2FF}"/>
              </a:ext>
            </a:extLst>
          </p:cNvPr>
          <p:cNvSpPr/>
          <p:nvPr/>
        </p:nvSpPr>
        <p:spPr>
          <a:xfrm>
            <a:off x="5920697" y="1097395"/>
            <a:ext cx="2438400" cy="4890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ktangel 8">
            <a:extLst>
              <a:ext uri="{FF2B5EF4-FFF2-40B4-BE49-F238E27FC236}">
                <a16:creationId xmlns:a16="http://schemas.microsoft.com/office/drawing/2014/main" id="{EEA20958-A6EA-97B1-4F09-E620842045D7}"/>
              </a:ext>
            </a:extLst>
          </p:cNvPr>
          <p:cNvSpPr/>
          <p:nvPr/>
        </p:nvSpPr>
        <p:spPr>
          <a:xfrm>
            <a:off x="1777999" y="1953554"/>
            <a:ext cx="3989139" cy="5293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0 provided data to the PRISM-CC measure</a:t>
            </a:r>
          </a:p>
        </p:txBody>
      </p:sp>
      <p:sp>
        <p:nvSpPr>
          <p:cNvPr id="12" name="Rektangel 9">
            <a:extLst>
              <a:ext uri="{FF2B5EF4-FFF2-40B4-BE49-F238E27FC236}">
                <a16:creationId xmlns:a16="http://schemas.microsoft.com/office/drawing/2014/main" id="{B418C249-566C-D392-149B-E206ACA179CE}"/>
              </a:ext>
            </a:extLst>
          </p:cNvPr>
          <p:cNvSpPr/>
          <p:nvPr/>
        </p:nvSpPr>
        <p:spPr>
          <a:xfrm>
            <a:off x="1777997" y="2622700"/>
            <a:ext cx="3989139" cy="1443794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6 were included in the psychometric analyses</a:t>
            </a:r>
          </a:p>
        </p:txBody>
      </p:sp>
      <p:sp>
        <p:nvSpPr>
          <p:cNvPr id="15" name="Rektangel 15">
            <a:extLst>
              <a:ext uri="{FF2B5EF4-FFF2-40B4-BE49-F238E27FC236}">
                <a16:creationId xmlns:a16="http://schemas.microsoft.com/office/drawing/2014/main" id="{BE78919A-2863-0520-D4D5-F625A7E285E5}"/>
              </a:ext>
            </a:extLst>
          </p:cNvPr>
          <p:cNvSpPr/>
          <p:nvPr/>
        </p:nvSpPr>
        <p:spPr>
          <a:xfrm>
            <a:off x="5916975" y="1631002"/>
            <a:ext cx="2438400" cy="46109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did not enter data in the PRISM-CC section of the survey </a:t>
            </a:r>
          </a:p>
        </p:txBody>
      </p:sp>
      <p:sp>
        <p:nvSpPr>
          <p:cNvPr id="22" name="Rektangel 18">
            <a:extLst>
              <a:ext uri="{FF2B5EF4-FFF2-40B4-BE49-F238E27FC236}">
                <a16:creationId xmlns:a16="http://schemas.microsoft.com/office/drawing/2014/main" id="{F78D6070-1FA4-9373-3153-8261B5CF6604}"/>
              </a:ext>
            </a:extLst>
          </p:cNvPr>
          <p:cNvSpPr/>
          <p:nvPr/>
        </p:nvSpPr>
        <p:spPr>
          <a:xfrm>
            <a:off x="1777997" y="4206249"/>
            <a:ext cx="3989140" cy="3830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were invited to test-retest</a:t>
            </a:r>
          </a:p>
        </p:txBody>
      </p:sp>
      <p:sp>
        <p:nvSpPr>
          <p:cNvPr id="23" name="Rektangel 23">
            <a:extLst>
              <a:ext uri="{FF2B5EF4-FFF2-40B4-BE49-F238E27FC236}">
                <a16:creationId xmlns:a16="http://schemas.microsoft.com/office/drawing/2014/main" id="{9A6A929D-1DF8-A204-4C6A-8572858D564C}"/>
              </a:ext>
            </a:extLst>
          </p:cNvPr>
          <p:cNvSpPr/>
          <p:nvPr/>
        </p:nvSpPr>
        <p:spPr>
          <a:xfrm>
            <a:off x="1777997" y="4720326"/>
            <a:ext cx="3989140" cy="3830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1 answered the test-retest</a:t>
            </a:r>
          </a:p>
        </p:txBody>
      </p:sp>
      <p:sp>
        <p:nvSpPr>
          <p:cNvPr id="24" name="Rektangel 24">
            <a:extLst>
              <a:ext uri="{FF2B5EF4-FFF2-40B4-BE49-F238E27FC236}">
                <a16:creationId xmlns:a16="http://schemas.microsoft.com/office/drawing/2014/main" id="{0E4EAA72-223C-BF36-D1CA-72D7EB2CEC7E}"/>
              </a:ext>
            </a:extLst>
          </p:cNvPr>
          <p:cNvSpPr/>
          <p:nvPr/>
        </p:nvSpPr>
        <p:spPr>
          <a:xfrm>
            <a:off x="1777997" y="5234403"/>
            <a:ext cx="3977420" cy="383004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8 were included in </a:t>
            </a:r>
            <a:r>
              <a:rPr lang="en-US" sz="11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retest</a:t>
            </a:r>
            <a:endParaRPr lang="en-US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ktangel 27">
            <a:extLst>
              <a:ext uri="{FF2B5EF4-FFF2-40B4-BE49-F238E27FC236}">
                <a16:creationId xmlns:a16="http://schemas.microsoft.com/office/drawing/2014/main" id="{F04235D1-9334-D95F-9E63-62BBE587519C}"/>
              </a:ext>
            </a:extLst>
          </p:cNvPr>
          <p:cNvSpPr/>
          <p:nvPr/>
        </p:nvSpPr>
        <p:spPr>
          <a:xfrm>
            <a:off x="5895973" y="4468508"/>
            <a:ext cx="2459402" cy="6798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3 were removed because of delayed response time or NA-or missing responses &gt;50%</a:t>
            </a:r>
          </a:p>
        </p:txBody>
      </p:sp>
      <p:sp>
        <p:nvSpPr>
          <p:cNvPr id="26" name="Rektangel 28">
            <a:extLst>
              <a:ext uri="{FF2B5EF4-FFF2-40B4-BE49-F238E27FC236}">
                <a16:creationId xmlns:a16="http://schemas.microsoft.com/office/drawing/2014/main" id="{E1EA1587-5A22-CD0C-20CA-5AE48D4F321F}"/>
              </a:ext>
            </a:extLst>
          </p:cNvPr>
          <p:cNvSpPr/>
          <p:nvPr/>
        </p:nvSpPr>
        <p:spPr>
          <a:xfrm>
            <a:off x="5916975" y="2157631"/>
            <a:ext cx="2438400" cy="54161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 had NA-or missing responses &gt;50%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29CCF2-30A0-DA19-A372-9A514260BAD5}"/>
              </a:ext>
            </a:extLst>
          </p:cNvPr>
          <p:cNvSpPr txBox="1"/>
          <p:nvPr/>
        </p:nvSpPr>
        <p:spPr>
          <a:xfrm>
            <a:off x="6016423" y="1131382"/>
            <a:ext cx="23389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75 were not eligible or chose not to take pa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122905-3DFA-4CF6-1040-DD2BD77CEC98}"/>
              </a:ext>
            </a:extLst>
          </p:cNvPr>
          <p:cNvSpPr txBox="1"/>
          <p:nvPr/>
        </p:nvSpPr>
        <p:spPr>
          <a:xfrm>
            <a:off x="704675" y="192947"/>
            <a:ext cx="35401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le 1. Flowchart of recruitment</a:t>
            </a:r>
          </a:p>
        </p:txBody>
      </p:sp>
      <p:sp>
        <p:nvSpPr>
          <p:cNvPr id="16" name="Pil: nedåt 15">
            <a:extLst>
              <a:ext uri="{FF2B5EF4-FFF2-40B4-BE49-F238E27FC236}">
                <a16:creationId xmlns:a16="http://schemas.microsoft.com/office/drawing/2014/main" id="{EC0337F2-15A3-EE98-A96F-AB4655831F6B}"/>
              </a:ext>
            </a:extLst>
          </p:cNvPr>
          <p:cNvSpPr/>
          <p:nvPr/>
        </p:nvSpPr>
        <p:spPr>
          <a:xfrm rot="16200000">
            <a:off x="5708284" y="1634804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7" name="Pil: nedåt 16">
            <a:extLst>
              <a:ext uri="{FF2B5EF4-FFF2-40B4-BE49-F238E27FC236}">
                <a16:creationId xmlns:a16="http://schemas.microsoft.com/office/drawing/2014/main" id="{015FB93D-081D-7C5A-9819-2E20B3B9CF2E}"/>
              </a:ext>
            </a:extLst>
          </p:cNvPr>
          <p:cNvSpPr/>
          <p:nvPr/>
        </p:nvSpPr>
        <p:spPr>
          <a:xfrm>
            <a:off x="3540670" y="5065936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8" name="Pil: nedåt 17">
            <a:extLst>
              <a:ext uri="{FF2B5EF4-FFF2-40B4-BE49-F238E27FC236}">
                <a16:creationId xmlns:a16="http://schemas.microsoft.com/office/drawing/2014/main" id="{595B0513-5FB0-73BD-C766-597ECD7CED54}"/>
              </a:ext>
            </a:extLst>
          </p:cNvPr>
          <p:cNvSpPr/>
          <p:nvPr/>
        </p:nvSpPr>
        <p:spPr>
          <a:xfrm>
            <a:off x="3540670" y="4513061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9" name="Pil: nedåt 18">
            <a:extLst>
              <a:ext uri="{FF2B5EF4-FFF2-40B4-BE49-F238E27FC236}">
                <a16:creationId xmlns:a16="http://schemas.microsoft.com/office/drawing/2014/main" id="{187711A1-9D3A-038E-CA1D-2668D3EA1350}"/>
              </a:ext>
            </a:extLst>
          </p:cNvPr>
          <p:cNvSpPr/>
          <p:nvPr/>
        </p:nvSpPr>
        <p:spPr>
          <a:xfrm>
            <a:off x="3540670" y="3960186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0" name="Pil: nedåt 19">
            <a:extLst>
              <a:ext uri="{FF2B5EF4-FFF2-40B4-BE49-F238E27FC236}">
                <a16:creationId xmlns:a16="http://schemas.microsoft.com/office/drawing/2014/main" id="{765EFC0C-6D9F-8BC9-D6C1-D9949F8E85AF}"/>
              </a:ext>
            </a:extLst>
          </p:cNvPr>
          <p:cNvSpPr/>
          <p:nvPr/>
        </p:nvSpPr>
        <p:spPr>
          <a:xfrm>
            <a:off x="3540670" y="2424906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8" name="Pil: nedåt 27">
            <a:extLst>
              <a:ext uri="{FF2B5EF4-FFF2-40B4-BE49-F238E27FC236}">
                <a16:creationId xmlns:a16="http://schemas.microsoft.com/office/drawing/2014/main" id="{0DBCC25F-5FE1-9103-56F9-718147A79B8F}"/>
              </a:ext>
            </a:extLst>
          </p:cNvPr>
          <p:cNvSpPr/>
          <p:nvPr/>
        </p:nvSpPr>
        <p:spPr>
          <a:xfrm>
            <a:off x="3540670" y="1742408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Pil: nedåt 28">
            <a:extLst>
              <a:ext uri="{FF2B5EF4-FFF2-40B4-BE49-F238E27FC236}">
                <a16:creationId xmlns:a16="http://schemas.microsoft.com/office/drawing/2014/main" id="{7DFBC631-BDB7-C047-5B30-6A7B77A9A117}"/>
              </a:ext>
            </a:extLst>
          </p:cNvPr>
          <p:cNvSpPr/>
          <p:nvPr/>
        </p:nvSpPr>
        <p:spPr>
          <a:xfrm rot="16200000">
            <a:off x="5717132" y="4716916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2" name="Pil: nedåt 31">
            <a:extLst>
              <a:ext uri="{FF2B5EF4-FFF2-40B4-BE49-F238E27FC236}">
                <a16:creationId xmlns:a16="http://schemas.microsoft.com/office/drawing/2014/main" id="{6063DAF2-5A79-1F81-74F7-76C415DC8B5C}"/>
              </a:ext>
            </a:extLst>
          </p:cNvPr>
          <p:cNvSpPr/>
          <p:nvPr/>
        </p:nvSpPr>
        <p:spPr>
          <a:xfrm rot="16200000">
            <a:off x="5717693" y="2207151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3" name="Pil: nedåt 32">
            <a:extLst>
              <a:ext uri="{FF2B5EF4-FFF2-40B4-BE49-F238E27FC236}">
                <a16:creationId xmlns:a16="http://schemas.microsoft.com/office/drawing/2014/main" id="{A0EE152F-B10D-F2C0-D132-C9AB6E344173}"/>
              </a:ext>
            </a:extLst>
          </p:cNvPr>
          <p:cNvSpPr/>
          <p:nvPr/>
        </p:nvSpPr>
        <p:spPr>
          <a:xfrm rot="16200000">
            <a:off x="5713971" y="1137945"/>
            <a:ext cx="323116" cy="274344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245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f13b610e-d3b5-490f-b165-988100e8232a}" enabled="1" method="Standard" siteId="{5a4ba6f9-f531-4f32-9467-398f19e69de4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494</TotalTime>
  <Words>93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T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grid Olsson</dc:creator>
  <cp:lastModifiedBy>Ingrid Olsson</cp:lastModifiedBy>
  <cp:revision>10</cp:revision>
  <dcterms:created xsi:type="dcterms:W3CDTF">2023-05-11T13:49:06Z</dcterms:created>
  <dcterms:modified xsi:type="dcterms:W3CDTF">2025-03-21T14:0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lassificationContentMarkingHeaderLocations">
    <vt:lpwstr>Office Theme:8</vt:lpwstr>
  </property>
  <property fmtid="{D5CDD505-2E9C-101B-9397-08002B2CF9AE}" pid="3" name="ClassificationContentMarkingHeaderText">
    <vt:lpwstr>Begränsad delning</vt:lpwstr>
  </property>
</Properties>
</file>